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8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90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082D29-D65E-7751-FE00-BA77B03C53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9BF8091-517E-B929-C1BB-AAA8FD00D9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B059AA-65F9-7B44-9B31-4CC6104E5B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85BDFC-440B-BF18-5ECF-FA054FE05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BD2CA5-995E-96A3-5A2D-CD272D8AE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606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93902C-A492-FE1B-F47C-763CEEDDDA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CE75458-CBAF-A9A7-8127-3E0C740544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28939FE-FE82-EE10-AF02-3B2A1983C4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A44551B-D356-B078-767D-B2FF37171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D803A4-C500-6FD9-B0D4-7A7E81BE7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6689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D96E4C9-6DB6-CB2F-F406-0CBDAF4A69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F67EB67-1D7E-1223-D7A1-3434FCF515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307B4A-D36D-7523-42B7-05144C22E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3BBDFC-76BA-E66D-AD65-979EDB9A33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49B52B-6802-1AD3-5143-DE266DB0A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758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BB6A32-A285-2DD4-5A8B-BBF458ABAB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8E3A1A2-DAD9-DBA6-9519-C8C289406A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F6D6142-5C19-4943-BE9F-93340B333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60F959-FC47-447E-CEEF-631DCA933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40DD049-F302-1C78-AE27-46A83D9CA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64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148AD8-99C0-2292-FDAA-C5FBBB8FF3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E3810C6-FFA5-AF7B-C185-810108D48B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1B37443-10EB-5424-B7A4-13A4365EB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9E159D9-AF74-E61D-F160-C11B96CE9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6E045C-2C86-16E8-2845-618F79720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6583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69992C-4561-66D7-2B14-F89A1792D1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D8BAEC8-F57C-5F3D-142F-A6DEB5824B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C81D607-96AE-B597-ACBF-11F89A8E8C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49CCE54-B683-570B-57A6-46DDB12EB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63A52F7-2AC0-6905-38B8-D4310904A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A143E8A-A29F-B347-C1AE-7FE884611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66575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A97BE6-C79A-7276-CEF5-4AA6888DC7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20C9107-BD6E-3454-C5AF-A61E402DF7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D7C6D79-6EFC-08C8-8826-07D742375D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A00371C-1D8E-E6CF-7BE6-3FFB58689F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CECD4B5-CE3E-FCF1-2282-85A7903B4C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95C8701-B7A5-5C2A-4495-CAB7F45B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12C84A9-6C95-B550-F6EF-4ABEE554C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EA7ABCE-E2F7-0DC1-AA90-222BA99E0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1279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3FF2B3-12F2-93D7-BA35-060B07F06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920DFD3-BE48-11F0-CB8F-9C6C75535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B844489-B9E3-002A-6E3E-58939010F9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112C9EE-F8F3-D0F5-4CA8-F547ECA46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3039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DB95376-37D1-3332-77B9-849113836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6C16940-C24C-00BB-7B30-7B153D536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5CEEAD4-8CFB-55E7-21F8-BB3C0021EC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316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3E9DC7-F759-8326-854E-F9CFFEBA0C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48C735-C5C9-08E2-E554-927E7F4025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BFE4C86-E6C5-263A-2DDE-B458677EC1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81635BA-BE8E-87B2-A857-D04B19762B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4196924-A86D-0B54-4610-8E59AF5F7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EB1D11C-F8B4-AAF4-22AD-2574A3377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342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C57ACF-2854-6234-5A53-926203D0B8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B515563-C849-4F4F-1F84-B454FD44E5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226E06C-8C37-6B16-6466-1134078A4A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A5B0295-4BD8-042D-E4A3-0F64B6320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C70B870-0261-3D0A-FBFF-504862B11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1EAC9C2-A9FE-3545-D265-5770C50FD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9125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7A423CD-780C-43EC-3809-B50AD0A723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5B44AD8-5B41-611B-A086-112E295B55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42685E-24E0-4619-C865-B53855DA87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5C43C6-26C9-4AAC-9302-AE4A2FD3E7CF}" type="datetimeFigureOut">
              <a:rPr kumimoji="1" lang="ja-JP" altLang="en-US" smtClean="0"/>
              <a:t>2025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E4BF2D-0EFA-59A8-4794-0070E9B2C0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837479-83BF-BCD4-E95E-C0B49D27C1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A64EC2F-5AC2-42CE-8A5C-EA16C849CF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9904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A195B92-B2D1-B51A-6D96-E7D278E61F3F}"/>
              </a:ext>
            </a:extLst>
          </p:cNvPr>
          <p:cNvSpPr txBox="1"/>
          <p:nvPr/>
        </p:nvSpPr>
        <p:spPr>
          <a:xfrm>
            <a:off x="1743077" y="5177165"/>
            <a:ext cx="8883641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gating strategy for extracting monocyte population.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Gating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pheral blood mononuclear cells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BMCs) on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ward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tter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SC-A)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ward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tter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ight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SC-H) to remove clumps and debris.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Broadly gating monocyte population on an FSC-A and side scatter area (SSC-A).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Gating CD14+ monocytes in PBMCs stained with CD14-FITC (upper panel) by referencing fluorescence minus one control (FMO) (lower panel)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id="{466C9BAD-06FA-9C49-541B-631A93813D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3077" y="508108"/>
            <a:ext cx="8705843" cy="46760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51973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44EA9DF-8ADE-EFB1-38D9-3958077B3F36}"/>
              </a:ext>
            </a:extLst>
          </p:cNvPr>
          <p:cNvSpPr txBox="1"/>
          <p:nvPr/>
        </p:nvSpPr>
        <p:spPr>
          <a:xfrm>
            <a:off x="2149315" y="4630654"/>
            <a:ext cx="7893370" cy="149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ceiver operating characteristics curves for determining the cutoff proportion of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-cell activation factor of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tumor necrosis factor family (BAFF) or a proliferation-inducing ligand (APRIL)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D14+ cells by using patients with antineutrophil cytoplasmic antibody-associated vasculitis (n = 35) 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s the objective variable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healthy controls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 = 22) as the control valuable.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The red line of each graph indicates the sensitivity and specificity in the proportion of BAFF and that of APRIL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468B1696-1BE9-B3E4-1BC6-224335B45A7C}"/>
              </a:ext>
            </a:extLst>
          </p:cNvPr>
          <p:cNvGrpSpPr/>
          <p:nvPr/>
        </p:nvGrpSpPr>
        <p:grpSpPr>
          <a:xfrm>
            <a:off x="2685299" y="972755"/>
            <a:ext cx="7059527" cy="3240000"/>
            <a:chOff x="2685299" y="972755"/>
            <a:chExt cx="7059527" cy="3240000"/>
          </a:xfrm>
        </p:grpSpPr>
        <p:pic>
          <p:nvPicPr>
            <p:cNvPr id="2" name="図 1" descr="図形, 矢印">
              <a:extLst>
                <a:ext uri="{FF2B5EF4-FFF2-40B4-BE49-F238E27FC236}">
                  <a16:creationId xmlns:a16="http://schemas.microsoft.com/office/drawing/2014/main" id="{66DC52DA-FBA8-B6C1-C1C0-04666CF5FBA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85299" y="972755"/>
              <a:ext cx="3839323" cy="3240000"/>
            </a:xfrm>
            <a:prstGeom prst="rect">
              <a:avLst/>
            </a:prstGeom>
          </p:spPr>
        </p:pic>
        <p:pic>
          <p:nvPicPr>
            <p:cNvPr id="3" name="図 2" descr="図形, 矢印">
              <a:extLst>
                <a:ext uri="{FF2B5EF4-FFF2-40B4-BE49-F238E27FC236}">
                  <a16:creationId xmlns:a16="http://schemas.microsoft.com/office/drawing/2014/main" id="{57CE6FA6-7CD9-8CEB-1654-502213C2E73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05503" y="972755"/>
              <a:ext cx="3839323" cy="324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830047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44FDE2B-A03D-D030-7D69-ECA84778FCE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8D8E33B1-C4B4-E9EC-39BD-D6182325BF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7736" y="429941"/>
            <a:ext cx="6096528" cy="479796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EA93FD7-F76A-92B7-0D57-7ABCB4A6CB5B}"/>
              </a:ext>
            </a:extLst>
          </p:cNvPr>
          <p:cNvSpPr txBox="1"/>
          <p:nvPr/>
        </p:nvSpPr>
        <p:spPr>
          <a:xfrm>
            <a:off x="2149315" y="5540400"/>
            <a:ext cx="789337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r>
              <a:rPr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s between median fluorescence intensity (MFI) of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nuclear factor-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κB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(NF-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κB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)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-cell activation factor of the tumor necrosis factor family (BAFF) or a proliferation-inducing ligand (APRIL)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D14+ cells with and without resveratrol (RVL) treatment in healthy controls (HC)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 = 12)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3243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233</Words>
  <Application>Microsoft Office PowerPoint</Application>
  <PresentationFormat>ワイド画面</PresentationFormat>
  <Paragraphs>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恭弘 下島</dc:creator>
  <cp:lastModifiedBy>恭弘 下島</cp:lastModifiedBy>
  <cp:revision>10</cp:revision>
  <dcterms:created xsi:type="dcterms:W3CDTF">2025-02-18T11:07:05Z</dcterms:created>
  <dcterms:modified xsi:type="dcterms:W3CDTF">2025-05-10T06:00:34Z</dcterms:modified>
</cp:coreProperties>
</file>